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09600" y="744120"/>
            <a:ext cx="257796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B3E0D2-647C-4502-A0AA-8492E4C4C455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sldImg"/>
          </p:nvPr>
        </p:nvSpPr>
        <p:spPr>
          <a:xfrm>
            <a:off x="2109960" y="744480"/>
            <a:ext cx="2577960" cy="3722760"/>
          </a:xfrm>
          <a:prstGeom prst="rect">
            <a:avLst/>
          </a:prstGeom>
          <a:ln w="0">
            <a:noFill/>
          </a:ln>
        </p:spPr>
      </p:sp>
      <p:sp>
        <p:nvSpPr>
          <p:cNvPr id="64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3 Marcador de número de diapositiva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33FC88-CB81-434B-BFFF-7A075DDD30D5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53B3FB-3608-456D-A4D9-6BFFA4A0B4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E03595-4B12-4C23-ADDF-C74FECD55A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CD8CAA-6399-451A-9698-B43F3D62387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8B5581-5B77-4806-BF0A-B5F96124F30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C18D73-A69F-4BDB-99DC-B886EA7A5F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72BC91-43E0-4A6F-9BCC-A5755D664D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09DBC5-D6FA-49C1-B965-A24278F226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0DBE45-4BE7-4E1B-B2ED-8679777FB9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FBC5E9-465F-4EEC-9767-110C6D5F98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E39AE7-DFD1-42AE-ABCA-0C1AA48E73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864E1E-239E-44BF-A17E-AA9C0E2903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3ABEF1-B0BB-4AFF-84F8-47F0073E67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E964F0-65EF-461E-A0BF-92ACC9CE709F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31 CuadroTexto"/>
          <p:cNvSpPr/>
          <p:nvPr/>
        </p:nvSpPr>
        <p:spPr>
          <a:xfrm>
            <a:off x="3600" y="-1584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4" descr="C:\Users\bragado\Google Drive\Resultats Article GC - Aran\2018.02.27_IF_InVivo_EGGS_II_RU_Laminin_p63\CNtExp\CNtExp 4\2018.02.27_IF_EGGS_Aran_RU_Laminin_p63_CntExp_4_H.tif"/>
          <p:cNvPicPr/>
          <p:nvPr/>
        </p:nvPicPr>
        <p:blipFill>
          <a:blip r:embed="rId1"/>
          <a:stretch/>
        </p:blipFill>
        <p:spPr>
          <a:xfrm>
            <a:off x="120600" y="638280"/>
            <a:ext cx="2133720" cy="160020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5" descr="C:\Users\bragado\Google Drive\Resultats Article GC - Aran\2018.02.27_IF_InVivo_EGGS_II_RU_Laminin_p63\CNtExp\CNtExp 4\2018.02.27_IF_EGGS_Aran_RU_Laminin_p63_CntExp_4_555.tif"/>
          <p:cNvPicPr/>
          <p:nvPr/>
        </p:nvPicPr>
        <p:blipFill>
          <a:blip r:embed="rId2"/>
          <a:stretch/>
        </p:blipFill>
        <p:spPr>
          <a:xfrm>
            <a:off x="2401920" y="631800"/>
            <a:ext cx="2133720" cy="160020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6" descr="C:\Users\bragado\Google Drive\Resultats Article GC - Aran\2018.02.27_IF_InVivo_EGGS_II_RU_Laminin_p63\CNtExp\CNtExp 4\2018.02.27_IF_EGGS_Aran_RU_Laminin_p63_CntExp_4_488.tif"/>
          <p:cNvPicPr/>
          <p:nvPr/>
        </p:nvPicPr>
        <p:blipFill>
          <a:blip r:embed="rId3"/>
          <a:stretch/>
        </p:blipFill>
        <p:spPr>
          <a:xfrm>
            <a:off x="4637160" y="638280"/>
            <a:ext cx="2133360" cy="160020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7" descr="C:\Users\bragado\Google Drive\Resultats Article GC - Aran\2018.02.27_IF_InVivo_EGGS_II_RU_Laminin_p63\CNtExp\CNtExp 4\2018.02.27_IF_EGGS_Aran_RU_Laminin_p63_CntExp_4.tif"/>
          <p:cNvPicPr/>
          <p:nvPr/>
        </p:nvPicPr>
        <p:blipFill>
          <a:blip r:embed="rId4"/>
          <a:stretch/>
        </p:blipFill>
        <p:spPr>
          <a:xfrm>
            <a:off x="120600" y="2994120"/>
            <a:ext cx="2133720" cy="159840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7" descr="C:\Users\bragado\Google Drive\Resultats Article GC - Aran\2018.02.27_IF_InVivo_EGGS_II_RU_Laminin_p63\CNtExp\CNtExp 4\2018.02.27_IF_EGGS_Aran_RU_Laminin_p63_CntExp_4.tif"/>
          <p:cNvPicPr/>
          <p:nvPr/>
        </p:nvPicPr>
        <p:blipFill>
          <a:blip r:embed="rId5"/>
          <a:srcRect l="50003" t="60511" r="25001" b="4668"/>
          <a:stretch/>
        </p:blipFill>
        <p:spPr>
          <a:xfrm>
            <a:off x="2470320" y="2994120"/>
            <a:ext cx="1511280" cy="1579320"/>
          </a:xfrm>
          <a:prstGeom prst="rect">
            <a:avLst/>
          </a:prstGeom>
          <a:ln w="0">
            <a:noFill/>
          </a:ln>
        </p:spPr>
      </p:pic>
      <p:sp>
        <p:nvSpPr>
          <p:cNvPr id="54" name="9 CuadroTexto"/>
          <p:cNvSpPr/>
          <p:nvPr/>
        </p:nvSpPr>
        <p:spPr>
          <a:xfrm>
            <a:off x="834840" y="361800"/>
            <a:ext cx="704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70c0"/>
                </a:solidFill>
                <a:latin typeface="Times New Roman"/>
              </a:rPr>
              <a:t>Hoech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44 CuadroTexto"/>
          <p:cNvSpPr/>
          <p:nvPr/>
        </p:nvSpPr>
        <p:spPr>
          <a:xfrm>
            <a:off x="3038040" y="344520"/>
            <a:ext cx="4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ff0000"/>
                </a:solidFill>
                <a:latin typeface="Times New Roman"/>
              </a:rPr>
              <a:t>p6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46 CuadroTexto"/>
          <p:cNvSpPr/>
          <p:nvPr/>
        </p:nvSpPr>
        <p:spPr>
          <a:xfrm>
            <a:off x="5275800" y="361800"/>
            <a:ext cx="74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b050"/>
                </a:solidFill>
                <a:latin typeface="Times New Roman"/>
              </a:rPr>
              <a:t>Lamin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47 CuadroTexto"/>
          <p:cNvSpPr/>
          <p:nvPr/>
        </p:nvSpPr>
        <p:spPr>
          <a:xfrm>
            <a:off x="469800" y="2716200"/>
            <a:ext cx="1589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70c0"/>
                </a:solidFill>
                <a:latin typeface="Times New Roman"/>
              </a:rPr>
              <a:t>Hoechst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/</a:t>
            </a:r>
            <a:r>
              <a:rPr b="1" lang="en-GB" sz="1200" spc="-1" strike="noStrike">
                <a:solidFill>
                  <a:srgbClr val="ff0000"/>
                </a:solidFill>
                <a:latin typeface="Times New Roman"/>
              </a:rPr>
              <a:t>p63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/</a:t>
            </a:r>
            <a:r>
              <a:rPr b="1" lang="en-GB" sz="1200" spc="-1" strike="noStrike">
                <a:solidFill>
                  <a:srgbClr val="00b050"/>
                </a:solidFill>
                <a:latin typeface="Times New Roman"/>
              </a:rPr>
              <a:t>Lamin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30 Conector recto"/>
          <p:cNvSpPr/>
          <p:nvPr/>
        </p:nvSpPr>
        <p:spPr>
          <a:xfrm flipV="1">
            <a:off x="1700280" y="2994120"/>
            <a:ext cx="770040" cy="98568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49 Conector recto"/>
          <p:cNvSpPr/>
          <p:nvPr/>
        </p:nvSpPr>
        <p:spPr>
          <a:xfrm>
            <a:off x="1700280" y="4484520"/>
            <a:ext cx="770040" cy="8892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38 Rectángulo"/>
          <p:cNvSpPr/>
          <p:nvPr/>
        </p:nvSpPr>
        <p:spPr>
          <a:xfrm>
            <a:off x="1187280" y="3979800"/>
            <a:ext cx="513000" cy="504720"/>
          </a:xfrm>
          <a:prstGeom prst="rect">
            <a:avLst/>
          </a:prstGeom>
          <a:noFill/>
          <a:ln w="284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ángulo 1"/>
          <p:cNvSpPr/>
          <p:nvPr/>
        </p:nvSpPr>
        <p:spPr>
          <a:xfrm>
            <a:off x="189000" y="5168880"/>
            <a:ext cx="61196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gure 4. Representative immunofluorescence images of MCF10DCIS xenografts in chicken embryo CAM membrane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. Hoechst in blue, p63 in red and laminin in green. B. Merge of p63 and laminin double immunofluorescence images and zoom in showing an acini detail. Scale bar=20 µm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15 CuadroTexto"/>
          <p:cNvSpPr/>
          <p:nvPr/>
        </p:nvSpPr>
        <p:spPr>
          <a:xfrm>
            <a:off x="18000" y="233028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7-30T14:25:21Z</dcterms:created>
  <dc:creator>INFORMAT - TECNIC DE SUPORT (DIR.SIST.INF.)</dc:creator>
  <dc:description/>
  <dc:language>en-US</dc:language>
  <cp:lastModifiedBy>gfuster</cp:lastModifiedBy>
  <cp:lastPrinted>2017-12-19T17:50:21Z</cp:lastPrinted>
  <dcterms:modified xsi:type="dcterms:W3CDTF">2018-03-15T16:47:43Z</dcterms:modified>
  <cp:revision>444</cp:revision>
  <dc:subject/>
  <dc:title>Presentación de PowerPoint</dc:title>
</cp:coreProperties>
</file>